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78" y="11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584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216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717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447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669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902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878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564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7857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752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470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B5F183-1B92-4731-B82E-CB15E0F9311F}" type="datetimeFigureOut">
              <a:rPr lang="en-US" smtClean="0"/>
              <a:t>1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F0DA4-1F91-46A9-A9FE-39CA02907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215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8375" y="1240790"/>
            <a:ext cx="5175250" cy="437642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-171578" y="-525560"/>
            <a:ext cx="2749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b="1" kern="100" dirty="0" smtClean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</a:t>
            </a:r>
            <a:endParaRPr lang="en-US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61038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845" y="1263332"/>
            <a:ext cx="5274310" cy="433133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0" y="-369332"/>
            <a:ext cx="2749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b="1" kern="100" dirty="0" smtClean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</a:t>
            </a:r>
            <a:endParaRPr lang="en-US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3896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Suppelementary fig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4957" y="205155"/>
            <a:ext cx="9527423" cy="66528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0" y="-509518"/>
            <a:ext cx="2749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b="1" kern="100" dirty="0" smtClean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3</a:t>
            </a:r>
            <a:endParaRPr lang="en-US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819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1558" y="0"/>
            <a:ext cx="2749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b="1" kern="100" smtClean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4</a:t>
            </a:r>
            <a:endParaRPr lang="en-US" kern="10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845" y="1945640"/>
            <a:ext cx="5274310" cy="296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02588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476" y="951030"/>
            <a:ext cx="10016523" cy="508080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823033" y="324671"/>
            <a:ext cx="2749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b="1" kern="100" dirty="0" smtClean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5</a:t>
            </a:r>
            <a:endParaRPr lang="en-US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05940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971" y="662272"/>
            <a:ext cx="10738418" cy="619572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77601" y="0"/>
            <a:ext cx="2749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b="1" kern="100" dirty="0" smtClean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6</a:t>
            </a:r>
            <a:endParaRPr lang="en-US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8127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9455" y="1345047"/>
            <a:ext cx="5274310" cy="400748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83003" y="340713"/>
            <a:ext cx="29161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b="1" kern="100" dirty="0" smtClean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7A</a:t>
            </a:r>
            <a:endParaRPr lang="en-US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67637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845" y="1447482"/>
            <a:ext cx="5274310" cy="396303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542662" y="148208"/>
            <a:ext cx="29161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/>
            <a:r>
              <a:rPr lang="en-US" b="1" kern="100" dirty="0" smtClean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7B</a:t>
            </a:r>
            <a:endParaRPr lang="en-US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8559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4</Words>
  <Application>Microsoft Office PowerPoint</Application>
  <PresentationFormat>Widescreen</PresentationFormat>
  <Paragraphs>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jid</dc:creator>
  <cp:lastModifiedBy>Sajid</cp:lastModifiedBy>
  <cp:revision>1</cp:revision>
  <dcterms:created xsi:type="dcterms:W3CDTF">2023-01-25T07:55:41Z</dcterms:created>
  <dcterms:modified xsi:type="dcterms:W3CDTF">2023-01-25T07:59:44Z</dcterms:modified>
</cp:coreProperties>
</file>